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4" d="100"/>
          <a:sy n="74" d="100"/>
        </p:scale>
        <p:origin x="73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78FD59A0-F753-4FD3-FE5A-9C79DD7DA1A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xmlns="" id="{EAD8B0D3-67C5-40FE-7F65-82280AF2139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xmlns="" id="{447683C4-FC90-2675-DF82-92137B66B0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ADD74-525B-4602-9C58-568AEE01B2B9}" type="datetimeFigureOut">
              <a:rPr lang="ko-KR" altLang="en-US" smtClean="0"/>
              <a:t>2023-10-1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xmlns="" id="{1E75B03D-5066-DB67-D4A7-A545DAD52C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xmlns="" id="{4D769C29-116B-EB62-BEBE-9F5D9BFF60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C075A-5C4C-4E2A-8BBC-38D7A5ADEE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229955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6F4B0DEC-7992-0709-BE64-2720A9A7BE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xmlns="" id="{AB8573E1-4453-D59E-0D1B-5331F5D8EB1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xmlns="" id="{F57A0D62-4E7C-DF02-BAD1-07CE930389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ADD74-525B-4602-9C58-568AEE01B2B9}" type="datetimeFigureOut">
              <a:rPr lang="ko-KR" altLang="en-US" smtClean="0"/>
              <a:t>2023-10-1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xmlns="" id="{29C51CAD-2CDC-8A6E-8CF6-385A980CAD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xmlns="" id="{37AB04D5-0A9A-0F78-461D-94A2D2D941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C075A-5C4C-4E2A-8BBC-38D7A5ADEE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09018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xmlns="" id="{D746C5F3-3610-A017-03C0-4475A87BC2F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xmlns="" id="{44A8CC51-A649-9F8F-ABC8-1282118C472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xmlns="" id="{35000C0F-F4D4-83AC-3419-C75166267D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ADD74-525B-4602-9C58-568AEE01B2B9}" type="datetimeFigureOut">
              <a:rPr lang="ko-KR" altLang="en-US" smtClean="0"/>
              <a:t>2023-10-1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xmlns="" id="{CC77A049-9D3F-EEAB-E5F7-6BA9272158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xmlns="" id="{9C4CC7C2-11C4-73EF-F8A8-8EC545E13E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C075A-5C4C-4E2A-8BBC-38D7A5ADEE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591409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2E448768-CB8A-59C5-BD4F-3F9A0DC78C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xmlns="" id="{AD99E810-82DD-E67A-9E09-68B1340F116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xmlns="" id="{7D14EBD0-6B48-2D4F-AA3E-BFF8715BEA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ADD74-525B-4602-9C58-568AEE01B2B9}" type="datetimeFigureOut">
              <a:rPr lang="ko-KR" altLang="en-US" smtClean="0"/>
              <a:t>2023-10-1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xmlns="" id="{5F778D2E-9EE9-0FB8-EAA5-BB06166360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xmlns="" id="{1078F203-72CE-65FB-AA44-DF4735F231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C075A-5C4C-4E2A-8BBC-38D7A5ADEE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354753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5A91F6C4-D245-F68A-D12C-122B9A6A95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xmlns="" id="{2CDE363F-1A81-B2B0-8106-CDBB882AEB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xmlns="" id="{3A379775-FACC-2068-0B65-0D04DD494D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ADD74-525B-4602-9C58-568AEE01B2B9}" type="datetimeFigureOut">
              <a:rPr lang="ko-KR" altLang="en-US" smtClean="0"/>
              <a:t>2023-10-1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xmlns="" id="{F2011CA7-B8A8-1DCD-E717-9236ECB09A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xmlns="" id="{7C3C08C0-787D-DF17-B000-347B479711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C075A-5C4C-4E2A-8BBC-38D7A5ADEE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535097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7467A71D-B098-EAE1-F9F3-587910434D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xmlns="" id="{FC1C5919-D6D3-AA99-324F-7CA9CC9F148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xmlns="" id="{C81F2170-C1B0-0FE7-0166-78FA9043946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xmlns="" id="{5B13B52A-512F-43A3-EB0E-D9FBF3FCB9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ADD74-525B-4602-9C58-568AEE01B2B9}" type="datetimeFigureOut">
              <a:rPr lang="ko-KR" altLang="en-US" smtClean="0"/>
              <a:t>2023-10-1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xmlns="" id="{41862496-BF5D-48FD-9651-9C9F942580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xmlns="" id="{F814759F-9626-4F3E-C17F-9F25FA43DA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C075A-5C4C-4E2A-8BBC-38D7A5ADEE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97891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CF0990D0-AA45-57E1-03D0-1D7B40EB39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xmlns="" id="{72FB8D64-62D3-5642-4244-DE5F0ED5B4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xmlns="" id="{2C4418FF-B4F2-E2C0-8355-310D6923015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xmlns="" id="{5B04C6BC-7531-B334-4DEE-A198617E728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xmlns="" id="{AD3A164F-4C7F-9245-0AA6-CEDD5A019F2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xmlns="" id="{FF405660-09D7-102E-8F7B-45EE51B194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ADD74-525B-4602-9C58-568AEE01B2B9}" type="datetimeFigureOut">
              <a:rPr lang="ko-KR" altLang="en-US" smtClean="0"/>
              <a:t>2023-10-18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xmlns="" id="{D9A1D26A-335F-04D6-E5FA-7B239D2C0F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xmlns="" id="{8C1187A2-5E6C-4A3A-B534-A330558BE7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C075A-5C4C-4E2A-8BBC-38D7A5ADEE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700625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7FC8799E-CD5A-04D2-05C2-87704B062F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xmlns="" id="{37E08381-368A-EDC9-3215-A6FFB38EE6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ADD74-525B-4602-9C58-568AEE01B2B9}" type="datetimeFigureOut">
              <a:rPr lang="ko-KR" altLang="en-US" smtClean="0"/>
              <a:t>2023-10-18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xmlns="" id="{9604BE9A-3919-BB96-5ADF-C17153E9E9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xmlns="" id="{7C36583D-15CE-09EE-F78E-D3361401D1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C075A-5C4C-4E2A-8BBC-38D7A5ADEE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912321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xmlns="" id="{F72102B2-9C5B-3376-C9DB-D275C40E23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ADD74-525B-4602-9C58-568AEE01B2B9}" type="datetimeFigureOut">
              <a:rPr lang="ko-KR" altLang="en-US" smtClean="0"/>
              <a:t>2023-10-18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xmlns="" id="{2BD531E1-16D6-28CE-8138-CA92602CCD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xmlns="" id="{1C2D7E09-297D-AC82-12E6-6CE8AF91E0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C075A-5C4C-4E2A-8BBC-38D7A5ADEE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99230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BC6D25D7-00CB-5483-3643-45C84D68C8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xmlns="" id="{0DC6C1F1-651A-B9B7-4F12-22597FA6486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xmlns="" id="{7BD99B73-1713-0EB1-F2B5-7686909DB79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xmlns="" id="{31E73FE5-7C9A-9772-8472-4937B1F622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ADD74-525B-4602-9C58-568AEE01B2B9}" type="datetimeFigureOut">
              <a:rPr lang="ko-KR" altLang="en-US" smtClean="0"/>
              <a:t>2023-10-1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xmlns="" id="{51609703-FD73-9A96-A6D2-FBAE112C21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xmlns="" id="{07DD3E88-D782-F9D4-56DD-BA7AC25459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C075A-5C4C-4E2A-8BBC-38D7A5ADEE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362095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4A3BF682-E3E2-FDEF-4340-CA06826768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xmlns="" id="{8340D25B-B0AD-DAE0-3215-01319A42250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xmlns="" id="{3AEF1F3D-0E6C-F997-D33D-E1724EAE497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xmlns="" id="{1B310985-F080-EFB2-0E50-1635D19496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ADD74-525B-4602-9C58-568AEE01B2B9}" type="datetimeFigureOut">
              <a:rPr lang="ko-KR" altLang="en-US" smtClean="0"/>
              <a:t>2023-10-1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xmlns="" id="{6B7CF1A0-3BF1-0A0F-6222-31F5143FF8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xmlns="" id="{F6561D11-B911-956C-6028-0392ADD974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C075A-5C4C-4E2A-8BBC-38D7A5ADEE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167046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xmlns="" id="{62D0ACD9-CB3B-594D-5CAE-802EFBAA94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xmlns="" id="{20980BD1-98CA-1DF8-7578-D26EC513BA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xmlns="" id="{2C9007C9-15E4-D344-18F7-89D59E9FBA6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0ADD74-525B-4602-9C58-568AEE01B2B9}" type="datetimeFigureOut">
              <a:rPr lang="ko-KR" altLang="en-US" smtClean="0"/>
              <a:t>2023-10-1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xmlns="" id="{312AD099-0E16-2111-49DA-03A7F3494C1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xmlns="" id="{2E2E4696-F1B6-6551-F34B-EA29DC48CEE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FC075A-5C4C-4E2A-8BBC-38D7A5ADEE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521312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B676B145-0339-F27B-A010-B00FAE4501C8}"/>
              </a:ext>
            </a:extLst>
          </p:cNvPr>
          <p:cNvSpPr txBox="1"/>
          <p:nvPr/>
        </p:nvSpPr>
        <p:spPr>
          <a:xfrm>
            <a:off x="464315" y="274676"/>
            <a:ext cx="38523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Funnel plots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7" name="그룹 26">
            <a:extLst>
              <a:ext uri="{FF2B5EF4-FFF2-40B4-BE49-F238E27FC236}">
                <a16:creationId xmlns:a16="http://schemas.microsoft.com/office/drawing/2014/main" xmlns="" id="{E84EF39E-0CBE-48AD-9D1A-E0015401F17E}"/>
              </a:ext>
            </a:extLst>
          </p:cNvPr>
          <p:cNvGrpSpPr/>
          <p:nvPr/>
        </p:nvGrpSpPr>
        <p:grpSpPr>
          <a:xfrm>
            <a:off x="444007" y="1241779"/>
            <a:ext cx="10797932" cy="5141258"/>
            <a:chOff x="444007" y="1241779"/>
            <a:chExt cx="10797932" cy="5141258"/>
          </a:xfrm>
        </p:grpSpPr>
        <p:grpSp>
          <p:nvGrpSpPr>
            <p:cNvPr id="5" name="그룹 4">
              <a:extLst>
                <a:ext uri="{FF2B5EF4-FFF2-40B4-BE49-F238E27FC236}">
                  <a16:creationId xmlns:a16="http://schemas.microsoft.com/office/drawing/2014/main" xmlns="" id="{EFD720A2-0B0C-4163-9B43-183FC660943E}"/>
                </a:ext>
              </a:extLst>
            </p:cNvPr>
            <p:cNvGrpSpPr/>
            <p:nvPr/>
          </p:nvGrpSpPr>
          <p:grpSpPr>
            <a:xfrm>
              <a:off x="444007" y="1241912"/>
              <a:ext cx="3484607" cy="2545200"/>
              <a:chOff x="444007" y="1241912"/>
              <a:chExt cx="3484607" cy="2545200"/>
            </a:xfrm>
          </p:grpSpPr>
          <p:pic>
            <p:nvPicPr>
              <p:cNvPr id="12" name="그림 11" descr="텍스트, 도표, 라인, 그래프이(가) 표시된 사진&#10;&#10;자동 생성된 설명">
                <a:extLst>
                  <a:ext uri="{FF2B5EF4-FFF2-40B4-BE49-F238E27FC236}">
                    <a16:creationId xmlns:a16="http://schemas.microsoft.com/office/drawing/2014/main" xmlns="" id="{BF74DBCC-3153-A7A0-53BE-0769BB9B77E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64315" y="1241912"/>
                <a:ext cx="3464299" cy="2545200"/>
              </a:xfrm>
              <a:prstGeom prst="rect">
                <a:avLst/>
              </a:prstGeom>
            </p:spPr>
          </p:pic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xmlns="" id="{80339CC6-47A0-8EA1-AD06-3B260D3FB520}"/>
                  </a:ext>
                </a:extLst>
              </p:cNvPr>
              <p:cNvSpPr txBox="1"/>
              <p:nvPr/>
            </p:nvSpPr>
            <p:spPr>
              <a:xfrm>
                <a:off x="1272757" y="1433445"/>
                <a:ext cx="1966470" cy="3077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tudies for DNA viruses</a:t>
                </a:r>
                <a:endParaRPr lang="ko-KR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" name="TextBox 2">
                <a:extLst>
                  <a:ext uri="{FF2B5EF4-FFF2-40B4-BE49-F238E27FC236}">
                    <a16:creationId xmlns:a16="http://schemas.microsoft.com/office/drawing/2014/main" xmlns="" id="{71282B72-29CE-4365-804E-B6334C674786}"/>
                  </a:ext>
                </a:extLst>
              </p:cNvPr>
              <p:cNvSpPr txBox="1"/>
              <p:nvPr/>
            </p:nvSpPr>
            <p:spPr>
              <a:xfrm>
                <a:off x="444007" y="1418056"/>
                <a:ext cx="45165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endParaRPr lang="ko-KR" alt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6" name="그룹 5">
              <a:extLst>
                <a:ext uri="{FF2B5EF4-FFF2-40B4-BE49-F238E27FC236}">
                  <a16:creationId xmlns:a16="http://schemas.microsoft.com/office/drawing/2014/main" xmlns="" id="{F9CFC379-05FA-4C34-94D2-E102683E9198}"/>
                </a:ext>
              </a:extLst>
            </p:cNvPr>
            <p:cNvGrpSpPr/>
            <p:nvPr/>
          </p:nvGrpSpPr>
          <p:grpSpPr>
            <a:xfrm>
              <a:off x="4047481" y="1241779"/>
              <a:ext cx="3540250" cy="2545466"/>
              <a:chOff x="4047481" y="1241779"/>
              <a:chExt cx="3540250" cy="2545466"/>
            </a:xfrm>
          </p:grpSpPr>
          <p:pic>
            <p:nvPicPr>
              <p:cNvPr id="14" name="그림 13" descr="텍스트, 라인, 도표, 그래프이(가) 표시된 사진&#10;&#10;자동 생성된 설명">
                <a:extLst>
                  <a:ext uri="{FF2B5EF4-FFF2-40B4-BE49-F238E27FC236}">
                    <a16:creationId xmlns:a16="http://schemas.microsoft.com/office/drawing/2014/main" xmlns="" id="{45CC9040-BA96-343E-792A-1C25CCC4DF9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123070" y="1241779"/>
                <a:ext cx="3464661" cy="2545466"/>
              </a:xfrm>
              <a:prstGeom prst="rect">
                <a:avLst/>
              </a:prstGeom>
            </p:spPr>
          </p:pic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xmlns="" id="{D70CD477-7A99-43DC-9E21-F7DBD6EF8B35}"/>
                  </a:ext>
                </a:extLst>
              </p:cNvPr>
              <p:cNvSpPr txBox="1"/>
              <p:nvPr/>
            </p:nvSpPr>
            <p:spPr>
              <a:xfrm>
                <a:off x="4967120" y="1433445"/>
                <a:ext cx="1966470" cy="3077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tudies for RNA viruses</a:t>
                </a:r>
                <a:endParaRPr lang="ko-KR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xmlns="" id="{8BD453B0-FC9D-455E-8398-FDC3F5AA0A38}"/>
                  </a:ext>
                </a:extLst>
              </p:cNvPr>
              <p:cNvSpPr txBox="1"/>
              <p:nvPr/>
            </p:nvSpPr>
            <p:spPr>
              <a:xfrm>
                <a:off x="4047481" y="1418056"/>
                <a:ext cx="45165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endParaRPr lang="ko-KR" alt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7" name="그룹 6">
              <a:extLst>
                <a:ext uri="{FF2B5EF4-FFF2-40B4-BE49-F238E27FC236}">
                  <a16:creationId xmlns:a16="http://schemas.microsoft.com/office/drawing/2014/main" xmlns="" id="{F409ED5D-4CB6-44A2-BD4A-FBF81A6D9B55}"/>
                </a:ext>
              </a:extLst>
            </p:cNvPr>
            <p:cNvGrpSpPr/>
            <p:nvPr/>
          </p:nvGrpSpPr>
          <p:grpSpPr>
            <a:xfrm>
              <a:off x="7703086" y="1241912"/>
              <a:ext cx="3538853" cy="2545200"/>
              <a:chOff x="7703086" y="1241912"/>
              <a:chExt cx="3538853" cy="2545200"/>
            </a:xfrm>
          </p:grpSpPr>
          <p:pic>
            <p:nvPicPr>
              <p:cNvPr id="16" name="그림 15" descr="텍스트, 라인, 도표, 그래프이(가) 표시된 사진&#10;&#10;자동 생성된 설명">
                <a:extLst>
                  <a:ext uri="{FF2B5EF4-FFF2-40B4-BE49-F238E27FC236}">
                    <a16:creationId xmlns:a16="http://schemas.microsoft.com/office/drawing/2014/main" xmlns="" id="{54C141E3-19D4-BB54-5BC2-E6CDA5B8C04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777640" y="1241912"/>
                <a:ext cx="3464299" cy="2545200"/>
              </a:xfrm>
              <a:prstGeom prst="rect">
                <a:avLst/>
              </a:prstGeom>
            </p:spPr>
          </p:pic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xmlns="" id="{03D705F5-3D80-48FC-A758-0A0F21725953}"/>
                  </a:ext>
                </a:extLst>
              </p:cNvPr>
              <p:cNvSpPr txBox="1"/>
              <p:nvPr/>
            </p:nvSpPr>
            <p:spPr>
              <a:xfrm>
                <a:off x="8531836" y="1433445"/>
                <a:ext cx="2163561" cy="3077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tudies for Retro  viruses</a:t>
                </a:r>
                <a:endParaRPr lang="ko-KR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xmlns="" id="{F2DA2A75-7D02-43CC-907B-0483C13504AA}"/>
                  </a:ext>
                </a:extLst>
              </p:cNvPr>
              <p:cNvSpPr txBox="1"/>
              <p:nvPr/>
            </p:nvSpPr>
            <p:spPr>
              <a:xfrm>
                <a:off x="7703086" y="1418056"/>
                <a:ext cx="45165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  <a:endParaRPr lang="ko-KR" alt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8" name="그룹 7">
              <a:extLst>
                <a:ext uri="{FF2B5EF4-FFF2-40B4-BE49-F238E27FC236}">
                  <a16:creationId xmlns:a16="http://schemas.microsoft.com/office/drawing/2014/main" xmlns="" id="{FD3A90B3-51EC-4D1B-9363-128F7168B7CF}"/>
                </a:ext>
              </a:extLst>
            </p:cNvPr>
            <p:cNvGrpSpPr/>
            <p:nvPr/>
          </p:nvGrpSpPr>
          <p:grpSpPr>
            <a:xfrm>
              <a:off x="1309087" y="3910400"/>
              <a:ext cx="3533930" cy="2472637"/>
              <a:chOff x="1997454" y="3817934"/>
              <a:chExt cx="3533930" cy="2472637"/>
            </a:xfrm>
          </p:grpSpPr>
          <p:pic>
            <p:nvPicPr>
              <p:cNvPr id="11" name="그림 10" descr="라인, 텍스트, 도표, 그래프이(가) 표시된 사진&#10;&#10;자동 생성된 설명">
                <a:extLst>
                  <a:ext uri="{FF2B5EF4-FFF2-40B4-BE49-F238E27FC236}">
                    <a16:creationId xmlns:a16="http://schemas.microsoft.com/office/drawing/2014/main" xmlns="" id="{6C627174-19AA-4DB4-A4E2-C148E47E991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066724" y="3817934"/>
                <a:ext cx="3464660" cy="2472637"/>
              </a:xfrm>
              <a:prstGeom prst="rect">
                <a:avLst/>
              </a:prstGeom>
            </p:spPr>
          </p:pic>
          <p:sp>
            <p:nvSpPr>
              <p:cNvPr id="2" name="직사각형 1">
                <a:extLst>
                  <a:ext uri="{FF2B5EF4-FFF2-40B4-BE49-F238E27FC236}">
                    <a16:creationId xmlns:a16="http://schemas.microsoft.com/office/drawing/2014/main" xmlns="" id="{1E24B4FF-9AB1-4E99-876F-094078679BCC}"/>
                  </a:ext>
                </a:extLst>
              </p:cNvPr>
              <p:cNvSpPr/>
              <p:nvPr/>
            </p:nvSpPr>
            <p:spPr>
              <a:xfrm>
                <a:off x="3181468" y="4022243"/>
                <a:ext cx="1481496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ko-KR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tudies for BDV*</a:t>
                </a:r>
                <a:endParaRPr lang="ko-KR" altLang="en-US" sz="1400" dirty="0"/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xmlns="" id="{91C4D7B8-C346-4102-B65D-B2D3941D3B59}"/>
                  </a:ext>
                </a:extLst>
              </p:cNvPr>
              <p:cNvSpPr txBox="1"/>
              <p:nvPr/>
            </p:nvSpPr>
            <p:spPr>
              <a:xfrm>
                <a:off x="1997454" y="4006854"/>
                <a:ext cx="45165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  <a:endParaRPr lang="ko-KR" alt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4" name="그룹 23">
              <a:extLst>
                <a:ext uri="{FF2B5EF4-FFF2-40B4-BE49-F238E27FC236}">
                  <a16:creationId xmlns:a16="http://schemas.microsoft.com/office/drawing/2014/main" xmlns="" id="{BE87EE86-A338-4317-BAC4-D48DE4C9E708}"/>
                </a:ext>
              </a:extLst>
            </p:cNvPr>
            <p:cNvGrpSpPr/>
            <p:nvPr/>
          </p:nvGrpSpPr>
          <p:grpSpPr>
            <a:xfrm>
              <a:off x="5190499" y="3910400"/>
              <a:ext cx="3542860" cy="2472637"/>
              <a:chOff x="5878866" y="3817934"/>
              <a:chExt cx="3542860" cy="2472637"/>
            </a:xfrm>
          </p:grpSpPr>
          <p:pic>
            <p:nvPicPr>
              <p:cNvPr id="13" name="그림 12" descr="텍스트, 라인, 도표, 그래프이(가) 표시된 사진&#10;&#10;자동 생성된 설명">
                <a:extLst>
                  <a:ext uri="{FF2B5EF4-FFF2-40B4-BE49-F238E27FC236}">
                    <a16:creationId xmlns:a16="http://schemas.microsoft.com/office/drawing/2014/main" xmlns="" id="{B0C5AC1C-68FB-40BB-AD83-143D59CFA13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950355" y="3817934"/>
                <a:ext cx="3471371" cy="2472637"/>
              </a:xfrm>
              <a:prstGeom prst="rect">
                <a:avLst/>
              </a:prstGeom>
            </p:spPr>
          </p:pic>
          <p:sp>
            <p:nvSpPr>
              <p:cNvPr id="15" name="직사각형 14">
                <a:extLst>
                  <a:ext uri="{FF2B5EF4-FFF2-40B4-BE49-F238E27FC236}">
                    <a16:creationId xmlns:a16="http://schemas.microsoft.com/office/drawing/2014/main" xmlns="" id="{6D4F733D-F4DB-4311-B2CB-D32B883C8B06}"/>
                  </a:ext>
                </a:extLst>
              </p:cNvPr>
              <p:cNvSpPr/>
              <p:nvPr/>
            </p:nvSpPr>
            <p:spPr>
              <a:xfrm>
                <a:off x="6710681" y="4022243"/>
                <a:ext cx="2223686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ko-KR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tudies for Parvovirus B19*</a:t>
                </a:r>
                <a:endParaRPr lang="ko-KR" altLang="en-US" sz="1400" dirty="0"/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xmlns="" id="{965B36AB-B201-4FEF-B2AB-F731BDEF7026}"/>
                  </a:ext>
                </a:extLst>
              </p:cNvPr>
              <p:cNvSpPr txBox="1"/>
              <p:nvPr/>
            </p:nvSpPr>
            <p:spPr>
              <a:xfrm>
                <a:off x="5878866" y="4006854"/>
                <a:ext cx="45165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</a:t>
                </a:r>
                <a:endParaRPr lang="ko-KR" alt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xmlns="" id="{52922105-EF0D-4CD4-AA8E-C05895A21E82}"/>
                </a:ext>
              </a:extLst>
            </p:cNvPr>
            <p:cNvSpPr txBox="1"/>
            <p:nvPr/>
          </p:nvSpPr>
          <p:spPr>
            <a:xfrm>
              <a:off x="8733359" y="4777386"/>
              <a:ext cx="1499703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174625" indent="-174625"/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: Available only compared with healthy control </a:t>
              </a:r>
              <a:endPara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1469402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5</TotalTime>
  <Words>38</Words>
  <Application>Microsoft Office PowerPoint</Application>
  <PresentationFormat>Widescreen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ae hyeon Hwang</dc:creator>
  <cp:lastModifiedBy>Poornima Thiruvudaiselvi</cp:lastModifiedBy>
  <cp:revision>14</cp:revision>
  <cp:lastPrinted>2023-09-23T11:38:29Z</cp:lastPrinted>
  <dcterms:created xsi:type="dcterms:W3CDTF">2023-09-23T07:47:28Z</dcterms:created>
  <dcterms:modified xsi:type="dcterms:W3CDTF">2023-10-18T10:45:38Z</dcterms:modified>
</cp:coreProperties>
</file>